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2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16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40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03CB3A29-022A-F447-BF05-57C12F7AB6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5441721"/>
              </p:ext>
            </p:extLst>
          </p:nvPr>
        </p:nvGraphicFramePr>
        <p:xfrm>
          <a:off x="2133599" y="861348"/>
          <a:ext cx="5334001" cy="2413000"/>
        </p:xfrm>
        <a:graphic>
          <a:graphicData uri="http://schemas.openxmlformats.org/drawingml/2006/table">
            <a:tbl>
              <a:tblPr/>
              <a:tblGrid>
                <a:gridCol w="1131455">
                  <a:extLst>
                    <a:ext uri="{9D8B030D-6E8A-4147-A177-3AD203B41FA5}">
                      <a16:colId xmlns:a16="http://schemas.microsoft.com/office/drawing/2014/main" val="4012198010"/>
                    </a:ext>
                  </a:extLst>
                </a:gridCol>
                <a:gridCol w="827198">
                  <a:extLst>
                    <a:ext uri="{9D8B030D-6E8A-4147-A177-3AD203B41FA5}">
                      <a16:colId xmlns:a16="http://schemas.microsoft.com/office/drawing/2014/main" val="1550500788"/>
                    </a:ext>
                  </a:extLst>
                </a:gridCol>
                <a:gridCol w="3375348">
                  <a:extLst>
                    <a:ext uri="{9D8B030D-6E8A-4147-A177-3AD203B41FA5}">
                      <a16:colId xmlns:a16="http://schemas.microsoft.com/office/drawing/2014/main" val="1831713406"/>
                    </a:ext>
                  </a:extLst>
                </a:gridCol>
              </a:tblGrid>
              <a:tr h="2413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lementary table 1. Primer sequence used in this stud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2531697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Ge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equen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425619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LK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orwa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CCCGAGCAGGTGCTTTTG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1744250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KLK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ever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GGAGTTCTTGACCCCAAA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085441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ZGP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orwa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ACGACAGTAACGGGTCTCAC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1740849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ZGP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ever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AGGCTGGGATTTCTTTGTTGAA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1790271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I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orwa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GCCAACAAAGCTCAGGACAAC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535066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I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ever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GCAGTGACTTCGTCATTTGGAC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385693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8Sr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orwa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 GTAACCCGTTGAACCCCATT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989514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8Sr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ever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5’- CCATCCAATCGGTAGTAGCG-3’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24713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9330612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61</Words>
  <Application>Microsoft Macintosh PowerPoint</Application>
  <PresentationFormat>A3 297x420 mm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7</cp:revision>
  <cp:lastPrinted>2019-11-15T20:26:41Z</cp:lastPrinted>
  <dcterms:created xsi:type="dcterms:W3CDTF">2019-06-11T17:31:31Z</dcterms:created>
  <dcterms:modified xsi:type="dcterms:W3CDTF">2021-04-22T08:24:10Z</dcterms:modified>
  <cp:category/>
</cp:coreProperties>
</file>